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2514" y="-6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eph\Downloads\OG1RF%20deletion%20growth%20curv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eph\Documents\Articles\Epa%20lysozyme%20paper\Final%20docs%20to%20submit\PLos%20Path\REVISED\OG1RF%20deletion%20growth%20curv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eph\Documents\Articles\Epa%20lysozyme%20paper\Final%20docs%20to%20submit\PLos%20Path\REVISED\OG1RF%20deletion%20growth%20curve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eph\Documents\Articles\Epa%20lysozyme%20paper\Final%20docs%20to%20submit\PLos%20Path\REVISED\OG1RF%20deletion%20growth%20curv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3116099849221"/>
          <c:y val="5.1130382438957171E-2"/>
          <c:w val="0.72801697660132914"/>
          <c:h val="0.79646216097987754"/>
        </c:manualLayout>
      </c:layout>
      <c:scatterChart>
        <c:scatterStyle val="lineMarker"/>
        <c:varyColors val="0"/>
        <c:ser>
          <c:idx val="0"/>
          <c:order val="0"/>
          <c:tx>
            <c:strRef>
              <c:f>'[OG1RF deletion growth curves.xlsx]Sheet1'!$B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[OG1RF deletion growth curves.xlsx]Sheet1'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'[OG1RF deletion growth curves.xlsx]Sheet1'!$B$17:$B$28</c:f>
              <c:numCache>
                <c:formatCode>0.00</c:formatCode>
                <c:ptCount val="12"/>
                <c:pt idx="0">
                  <c:v>0.02</c:v>
                </c:pt>
                <c:pt idx="1">
                  <c:v>0.08</c:v>
                </c:pt>
                <c:pt idx="2">
                  <c:v>0.18000000000000002</c:v>
                </c:pt>
                <c:pt idx="3">
                  <c:v>0.34</c:v>
                </c:pt>
                <c:pt idx="4">
                  <c:v>0.64666666666666661</c:v>
                </c:pt>
                <c:pt idx="5">
                  <c:v>0.91333333333333344</c:v>
                </c:pt>
                <c:pt idx="6">
                  <c:v>1.1933333333333334</c:v>
                </c:pt>
                <c:pt idx="7">
                  <c:v>1.3999999999999997</c:v>
                </c:pt>
                <c:pt idx="8">
                  <c:v>1.3533333333333335</c:v>
                </c:pt>
                <c:pt idx="9">
                  <c:v>1.36</c:v>
                </c:pt>
                <c:pt idx="10">
                  <c:v>1.3666666666666669</c:v>
                </c:pt>
                <c:pt idx="11">
                  <c:v>1.366666666666666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[OG1RF deletion growth curves.xlsx]Sheet1'!$E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triang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'[OG1RF deletion growth curves.xlsx]Sheet1'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'[OG1RF deletion growth curves.xlsx]Sheet1'!$E$17:$E$28</c:f>
              <c:numCache>
                <c:formatCode>0.00</c:formatCode>
                <c:ptCount val="12"/>
                <c:pt idx="0">
                  <c:v>0.02</c:v>
                </c:pt>
                <c:pt idx="1">
                  <c:v>7.0000000000000007E-2</c:v>
                </c:pt>
                <c:pt idx="2">
                  <c:v>0.13333333333333333</c:v>
                </c:pt>
                <c:pt idx="3">
                  <c:v>0.2233333333333333</c:v>
                </c:pt>
                <c:pt idx="4">
                  <c:v>0.40666666666666668</c:v>
                </c:pt>
                <c:pt idx="5">
                  <c:v>0.66666666666666663</c:v>
                </c:pt>
                <c:pt idx="6">
                  <c:v>0.98</c:v>
                </c:pt>
                <c:pt idx="7">
                  <c:v>1.2466666666666668</c:v>
                </c:pt>
                <c:pt idx="8">
                  <c:v>1.36</c:v>
                </c:pt>
                <c:pt idx="9">
                  <c:v>1.3466666666666667</c:v>
                </c:pt>
                <c:pt idx="10">
                  <c:v>1.3733333333333333</c:v>
                </c:pt>
                <c:pt idx="11">
                  <c:v>1.373333333333333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[OG1RF deletion growth curves.xlsx]Sheet1'!$H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[OG1RF deletion growth curves.xlsx]Sheet1'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'[OG1RF deletion growth curves.xlsx]Sheet1'!$H$17:$H$28</c:f>
              <c:numCache>
                <c:formatCode>0.00</c:formatCode>
                <c:ptCount val="12"/>
                <c:pt idx="0">
                  <c:v>0.02</c:v>
                </c:pt>
                <c:pt idx="1">
                  <c:v>7.3333333333333348E-2</c:v>
                </c:pt>
                <c:pt idx="2">
                  <c:v>0.14333333333333334</c:v>
                </c:pt>
                <c:pt idx="3">
                  <c:v>0.25</c:v>
                </c:pt>
                <c:pt idx="4">
                  <c:v>0.44333333333333336</c:v>
                </c:pt>
                <c:pt idx="5">
                  <c:v>0.68666666666666665</c:v>
                </c:pt>
                <c:pt idx="6">
                  <c:v>0.92</c:v>
                </c:pt>
                <c:pt idx="7">
                  <c:v>1.2933333333333332</c:v>
                </c:pt>
                <c:pt idx="8">
                  <c:v>1.4000000000000001</c:v>
                </c:pt>
                <c:pt idx="9">
                  <c:v>1.3533333333333335</c:v>
                </c:pt>
                <c:pt idx="10">
                  <c:v>1.36</c:v>
                </c:pt>
                <c:pt idx="11">
                  <c:v>1.3466666666666667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[OG1RF deletion growth curves.xlsx]Sheet1'!$K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'[OG1RF deletion growth curves.xlsx]Sheet1'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'[OG1RF deletion growth curves.xlsx]Sheet1'!$K$17:$K$28</c:f>
              <c:numCache>
                <c:formatCode>0.00</c:formatCode>
                <c:ptCount val="12"/>
                <c:pt idx="0">
                  <c:v>0.02</c:v>
                </c:pt>
                <c:pt idx="1">
                  <c:v>0.06</c:v>
                </c:pt>
                <c:pt idx="2">
                  <c:v>0.12</c:v>
                </c:pt>
                <c:pt idx="3">
                  <c:v>0.20000000000000004</c:v>
                </c:pt>
                <c:pt idx="4">
                  <c:v>0.36000000000000004</c:v>
                </c:pt>
                <c:pt idx="5">
                  <c:v>0.59</c:v>
                </c:pt>
                <c:pt idx="6">
                  <c:v>0.85666666666666658</c:v>
                </c:pt>
                <c:pt idx="7">
                  <c:v>1.2</c:v>
                </c:pt>
                <c:pt idx="8">
                  <c:v>1.3999999999999997</c:v>
                </c:pt>
                <c:pt idx="9">
                  <c:v>1.36</c:v>
                </c:pt>
                <c:pt idx="10">
                  <c:v>1.3866666666666667</c:v>
                </c:pt>
                <c:pt idx="11">
                  <c:v>1.393333333333333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603648"/>
        <c:axId val="192606592"/>
      </c:scatterChart>
      <c:valAx>
        <c:axId val="192603648"/>
        <c:scaling>
          <c:orientation val="minMax"/>
          <c:max val="6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Time (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92606592"/>
        <c:crossesAt val="1.0000000000000002E-2"/>
        <c:crossBetween val="midCat"/>
        <c:majorUnit val="1"/>
      </c:valAx>
      <c:valAx>
        <c:axId val="192606592"/>
        <c:scaling>
          <c:logBase val="10"/>
          <c:orientation val="minMax"/>
          <c:max val="1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GB" sz="1400"/>
                  <a:t>OD</a:t>
                </a:r>
                <a:r>
                  <a:rPr lang="en-GB" sz="1400" baseline="-25000"/>
                  <a:t>600nm</a:t>
                </a:r>
              </a:p>
            </c:rich>
          </c:tx>
          <c:layout>
            <c:manualLayout>
              <c:xMode val="edge"/>
              <c:yMode val="edge"/>
              <c:x val="1.7460100691163355E-2"/>
              <c:y val="0.32646796573070552"/>
            </c:manualLayout>
          </c:layout>
          <c:overlay val="0"/>
        </c:title>
        <c:numFmt formatCode="0.00" sourceLinked="1"/>
        <c:majorTickMark val="out"/>
        <c:minorTickMark val="out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92603648"/>
        <c:crossesAt val="0"/>
        <c:crossBetween val="midCat"/>
      </c:valAx>
    </c:plotArea>
    <c:legend>
      <c:legendPos val="r"/>
      <c:layout>
        <c:manualLayout>
          <c:xMode val="edge"/>
          <c:yMode val="edge"/>
          <c:x val="0.25803531248080991"/>
          <c:y val="0.56796861334096793"/>
          <c:w val="0.15759848917427929"/>
          <c:h val="0.25013451443569557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3116099849221"/>
          <c:y val="5.1130382438957171E-2"/>
          <c:w val="0.72801697660132914"/>
          <c:h val="0.7964621609798775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B$17:$B$28</c:f>
              <c:numCache>
                <c:formatCode>0.00</c:formatCode>
                <c:ptCount val="12"/>
                <c:pt idx="0">
                  <c:v>0.02</c:v>
                </c:pt>
                <c:pt idx="1">
                  <c:v>0.08</c:v>
                </c:pt>
                <c:pt idx="2">
                  <c:v>0.18000000000000002</c:v>
                </c:pt>
                <c:pt idx="3">
                  <c:v>0.34</c:v>
                </c:pt>
                <c:pt idx="4">
                  <c:v>0.64666666666666661</c:v>
                </c:pt>
                <c:pt idx="5">
                  <c:v>0.91333333333333344</c:v>
                </c:pt>
                <c:pt idx="6">
                  <c:v>1.1933333333333334</c:v>
                </c:pt>
                <c:pt idx="7">
                  <c:v>1.3999999999999997</c:v>
                </c:pt>
                <c:pt idx="8">
                  <c:v>1.3533333333333335</c:v>
                </c:pt>
                <c:pt idx="9">
                  <c:v>1.36</c:v>
                </c:pt>
                <c:pt idx="10">
                  <c:v>1.3666666666666669</c:v>
                </c:pt>
                <c:pt idx="11">
                  <c:v>1.366666666666666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E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triang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E$17:$E$28</c:f>
              <c:numCache>
                <c:formatCode>0.00</c:formatCode>
                <c:ptCount val="12"/>
                <c:pt idx="0">
                  <c:v>0.02</c:v>
                </c:pt>
                <c:pt idx="1">
                  <c:v>7.0000000000000007E-2</c:v>
                </c:pt>
                <c:pt idx="2">
                  <c:v>0.13333333333333333</c:v>
                </c:pt>
                <c:pt idx="3">
                  <c:v>0.2233333333333333</c:v>
                </c:pt>
                <c:pt idx="4">
                  <c:v>0.40666666666666668</c:v>
                </c:pt>
                <c:pt idx="5">
                  <c:v>0.66666666666666663</c:v>
                </c:pt>
                <c:pt idx="6">
                  <c:v>0.98</c:v>
                </c:pt>
                <c:pt idx="7">
                  <c:v>1.2466666666666668</c:v>
                </c:pt>
                <c:pt idx="8">
                  <c:v>1.36</c:v>
                </c:pt>
                <c:pt idx="9">
                  <c:v>1.3466666666666667</c:v>
                </c:pt>
                <c:pt idx="10">
                  <c:v>1.3733333333333333</c:v>
                </c:pt>
                <c:pt idx="11">
                  <c:v>1.373333333333333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1!$H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N$17:$N$28</c:f>
              <c:numCache>
                <c:formatCode>0.00</c:formatCode>
                <c:ptCount val="12"/>
                <c:pt idx="0">
                  <c:v>0.02</c:v>
                </c:pt>
                <c:pt idx="1">
                  <c:v>6.3333333333333339E-2</c:v>
                </c:pt>
                <c:pt idx="2">
                  <c:v>0.12666666666666668</c:v>
                </c:pt>
                <c:pt idx="3">
                  <c:v>0.22333333333333336</c:v>
                </c:pt>
                <c:pt idx="4">
                  <c:v>0.39999999999999997</c:v>
                </c:pt>
                <c:pt idx="5">
                  <c:v>0.65</c:v>
                </c:pt>
                <c:pt idx="6">
                  <c:v>0.89</c:v>
                </c:pt>
                <c:pt idx="7">
                  <c:v>1.2533333333333332</c:v>
                </c:pt>
                <c:pt idx="8">
                  <c:v>1.3666666666666669</c:v>
                </c:pt>
                <c:pt idx="9">
                  <c:v>1.28</c:v>
                </c:pt>
                <c:pt idx="10">
                  <c:v>1.3266666666666669</c:v>
                </c:pt>
                <c:pt idx="11">
                  <c:v>1.26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1!$K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Q$17:$Q$28</c:f>
              <c:numCache>
                <c:formatCode>0.00</c:formatCode>
                <c:ptCount val="12"/>
                <c:pt idx="0">
                  <c:v>0.02</c:v>
                </c:pt>
                <c:pt idx="1">
                  <c:v>0.06</c:v>
                </c:pt>
                <c:pt idx="2">
                  <c:v>0.11333333333333333</c:v>
                </c:pt>
                <c:pt idx="3">
                  <c:v>0.19000000000000003</c:v>
                </c:pt>
                <c:pt idx="4">
                  <c:v>0.34333333333333332</c:v>
                </c:pt>
                <c:pt idx="5">
                  <c:v>0.56000000000000005</c:v>
                </c:pt>
                <c:pt idx="6">
                  <c:v>0.78666666666666663</c:v>
                </c:pt>
                <c:pt idx="7">
                  <c:v>1.1933333333333334</c:v>
                </c:pt>
                <c:pt idx="8">
                  <c:v>1.3866666666666667</c:v>
                </c:pt>
                <c:pt idx="9">
                  <c:v>1.3733333333333333</c:v>
                </c:pt>
                <c:pt idx="10">
                  <c:v>1.3933333333333333</c:v>
                </c:pt>
                <c:pt idx="11">
                  <c:v>1.399999999999999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173568"/>
        <c:axId val="194176128"/>
      </c:scatterChart>
      <c:valAx>
        <c:axId val="194173568"/>
        <c:scaling>
          <c:orientation val="minMax"/>
          <c:max val="6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Time (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94176128"/>
        <c:crossesAt val="1.0000000000000002E-2"/>
        <c:crossBetween val="midCat"/>
        <c:majorUnit val="1"/>
      </c:valAx>
      <c:valAx>
        <c:axId val="194176128"/>
        <c:scaling>
          <c:logBase val="10"/>
          <c:orientation val="minMax"/>
          <c:max val="1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GB" sz="1400"/>
                  <a:t>OD</a:t>
                </a:r>
                <a:r>
                  <a:rPr lang="en-GB" sz="1400" baseline="-25000"/>
                  <a:t>600nm</a:t>
                </a:r>
              </a:p>
            </c:rich>
          </c:tx>
          <c:layout>
            <c:manualLayout>
              <c:xMode val="edge"/>
              <c:yMode val="edge"/>
              <c:x val="1.4609872684737815E-2"/>
              <c:y val="0.32646801284791732"/>
            </c:manualLayout>
          </c:layout>
          <c:overlay val="0"/>
        </c:title>
        <c:numFmt formatCode="0.00" sourceLinked="1"/>
        <c:majorTickMark val="out"/>
        <c:minorTickMark val="out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94173568"/>
        <c:crossesAt val="0"/>
        <c:crossBetween val="midCat"/>
      </c:valAx>
    </c:plotArea>
    <c:legend>
      <c:legendPos val="r"/>
      <c:layout>
        <c:manualLayout>
          <c:xMode val="edge"/>
          <c:yMode val="edge"/>
          <c:x val="0.25196416508834024"/>
          <c:y val="0.56796850119377129"/>
          <c:w val="0.15759848917427929"/>
          <c:h val="0.25013451443569557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3116099849221"/>
          <c:y val="5.1130382438957171E-2"/>
          <c:w val="0.72801697660132914"/>
          <c:h val="0.7964621609798775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B$17:$B$28</c:f>
              <c:numCache>
                <c:formatCode>0.00</c:formatCode>
                <c:ptCount val="12"/>
                <c:pt idx="0">
                  <c:v>0.02</c:v>
                </c:pt>
                <c:pt idx="1">
                  <c:v>0.08</c:v>
                </c:pt>
                <c:pt idx="2">
                  <c:v>0.18000000000000002</c:v>
                </c:pt>
                <c:pt idx="3">
                  <c:v>0.34</c:v>
                </c:pt>
                <c:pt idx="4">
                  <c:v>0.64666666666666661</c:v>
                </c:pt>
                <c:pt idx="5">
                  <c:v>0.91333333333333344</c:v>
                </c:pt>
                <c:pt idx="6">
                  <c:v>1.1933333333333334</c:v>
                </c:pt>
                <c:pt idx="7">
                  <c:v>1.3999999999999997</c:v>
                </c:pt>
                <c:pt idx="8">
                  <c:v>1.3533333333333335</c:v>
                </c:pt>
                <c:pt idx="9">
                  <c:v>1.36</c:v>
                </c:pt>
                <c:pt idx="10">
                  <c:v>1.3666666666666669</c:v>
                </c:pt>
                <c:pt idx="11">
                  <c:v>1.366666666666666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E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triang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E$17:$E$28</c:f>
              <c:numCache>
                <c:formatCode>0.00</c:formatCode>
                <c:ptCount val="12"/>
                <c:pt idx="0">
                  <c:v>0.02</c:v>
                </c:pt>
                <c:pt idx="1">
                  <c:v>7.0000000000000007E-2</c:v>
                </c:pt>
                <c:pt idx="2">
                  <c:v>0.13333333333333333</c:v>
                </c:pt>
                <c:pt idx="3">
                  <c:v>0.2233333333333333</c:v>
                </c:pt>
                <c:pt idx="4">
                  <c:v>0.40666666666666668</c:v>
                </c:pt>
                <c:pt idx="5">
                  <c:v>0.66666666666666663</c:v>
                </c:pt>
                <c:pt idx="6">
                  <c:v>0.98</c:v>
                </c:pt>
                <c:pt idx="7">
                  <c:v>1.2466666666666668</c:v>
                </c:pt>
                <c:pt idx="8">
                  <c:v>1.36</c:v>
                </c:pt>
                <c:pt idx="9">
                  <c:v>1.3466666666666667</c:v>
                </c:pt>
                <c:pt idx="10">
                  <c:v>1.3733333333333333</c:v>
                </c:pt>
                <c:pt idx="11">
                  <c:v>1.373333333333333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1!$H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T$17:$T$28</c:f>
              <c:numCache>
                <c:formatCode>0.00</c:formatCode>
                <c:ptCount val="12"/>
                <c:pt idx="0">
                  <c:v>0.02</c:v>
                </c:pt>
                <c:pt idx="1">
                  <c:v>0.10000000000000002</c:v>
                </c:pt>
                <c:pt idx="2">
                  <c:v>0.19333333333333336</c:v>
                </c:pt>
                <c:pt idx="3">
                  <c:v>0.36999999999999994</c:v>
                </c:pt>
                <c:pt idx="4">
                  <c:v>0.62666666666666659</c:v>
                </c:pt>
                <c:pt idx="5">
                  <c:v>0.88666666666666671</c:v>
                </c:pt>
                <c:pt idx="6">
                  <c:v>1.24</c:v>
                </c:pt>
                <c:pt idx="7">
                  <c:v>1.3733333333333333</c:v>
                </c:pt>
                <c:pt idx="8">
                  <c:v>1.3333333333333333</c:v>
                </c:pt>
                <c:pt idx="9">
                  <c:v>1.3266666666666669</c:v>
                </c:pt>
                <c:pt idx="10">
                  <c:v>1.3466666666666667</c:v>
                </c:pt>
                <c:pt idx="11">
                  <c:v>1.3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1!$K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W$17:$W$28</c:f>
              <c:numCache>
                <c:formatCode>0.00</c:formatCode>
                <c:ptCount val="12"/>
                <c:pt idx="0">
                  <c:v>0.02</c:v>
                </c:pt>
                <c:pt idx="1">
                  <c:v>8.3333333333333329E-2</c:v>
                </c:pt>
                <c:pt idx="2">
                  <c:v>0.14000000000000001</c:v>
                </c:pt>
                <c:pt idx="3">
                  <c:v>0.25</c:v>
                </c:pt>
                <c:pt idx="4">
                  <c:v>0.41333333333333333</c:v>
                </c:pt>
                <c:pt idx="5">
                  <c:v>0.70333333333333348</c:v>
                </c:pt>
                <c:pt idx="6">
                  <c:v>1.0266666666666666</c:v>
                </c:pt>
                <c:pt idx="7">
                  <c:v>1.2533333333333332</c:v>
                </c:pt>
                <c:pt idx="8">
                  <c:v>1.3466666666666667</c:v>
                </c:pt>
                <c:pt idx="9">
                  <c:v>1.3933333333333333</c:v>
                </c:pt>
                <c:pt idx="10">
                  <c:v>1.42</c:v>
                </c:pt>
                <c:pt idx="11">
                  <c:v>1.3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534400"/>
        <c:axId val="260113920"/>
      </c:scatterChart>
      <c:valAx>
        <c:axId val="194534400"/>
        <c:scaling>
          <c:orientation val="minMax"/>
          <c:max val="6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Time (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260113920"/>
        <c:crossesAt val="1.0000000000000002E-2"/>
        <c:crossBetween val="midCat"/>
        <c:majorUnit val="1"/>
      </c:valAx>
      <c:valAx>
        <c:axId val="260113920"/>
        <c:scaling>
          <c:logBase val="10"/>
          <c:orientation val="minMax"/>
          <c:max val="1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GB" sz="1400"/>
                  <a:t>OD</a:t>
                </a:r>
                <a:r>
                  <a:rPr lang="en-GB" sz="1400" baseline="-25000"/>
                  <a:t>600nm</a:t>
                </a:r>
              </a:p>
            </c:rich>
          </c:tx>
          <c:layout>
            <c:manualLayout>
              <c:xMode val="edge"/>
              <c:yMode val="edge"/>
              <c:x val="1.7531847221685378E-2"/>
              <c:y val="0.32646801284791732"/>
            </c:manualLayout>
          </c:layout>
          <c:overlay val="0"/>
        </c:title>
        <c:numFmt formatCode="0.00" sourceLinked="1"/>
        <c:majorTickMark val="out"/>
        <c:minorTickMark val="out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94534400"/>
        <c:crossesAt val="0"/>
        <c:crossBetween val="midCat"/>
      </c:valAx>
    </c:plotArea>
    <c:legend>
      <c:legendPos val="r"/>
      <c:layout>
        <c:manualLayout>
          <c:xMode val="edge"/>
          <c:yMode val="edge"/>
          <c:x val="0.26073008869918296"/>
          <c:y val="0.56796850119377129"/>
          <c:w val="0.15759848917427929"/>
          <c:h val="0.25013451443569557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3116099849221"/>
          <c:y val="5.1130382438957171E-2"/>
          <c:w val="0.72801697660132914"/>
          <c:h val="0.7964621609798775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B$17:$B$28</c:f>
              <c:numCache>
                <c:formatCode>0.00</c:formatCode>
                <c:ptCount val="12"/>
                <c:pt idx="0">
                  <c:v>0.02</c:v>
                </c:pt>
                <c:pt idx="1">
                  <c:v>0.08</c:v>
                </c:pt>
                <c:pt idx="2">
                  <c:v>0.18000000000000002</c:v>
                </c:pt>
                <c:pt idx="3">
                  <c:v>0.34</c:v>
                </c:pt>
                <c:pt idx="4">
                  <c:v>0.64666666666666661</c:v>
                </c:pt>
                <c:pt idx="5">
                  <c:v>0.91333333333333344</c:v>
                </c:pt>
                <c:pt idx="6">
                  <c:v>1.1933333333333334</c:v>
                </c:pt>
                <c:pt idx="7">
                  <c:v>1.3999999999999997</c:v>
                </c:pt>
                <c:pt idx="8">
                  <c:v>1.3533333333333335</c:v>
                </c:pt>
                <c:pt idx="9">
                  <c:v>1.36</c:v>
                </c:pt>
                <c:pt idx="10">
                  <c:v>1.3666666666666669</c:v>
                </c:pt>
                <c:pt idx="11">
                  <c:v>1.366666666666666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E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triang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E$17:$E$28</c:f>
              <c:numCache>
                <c:formatCode>0.00</c:formatCode>
                <c:ptCount val="12"/>
                <c:pt idx="0">
                  <c:v>0.02</c:v>
                </c:pt>
                <c:pt idx="1">
                  <c:v>7.0000000000000007E-2</c:v>
                </c:pt>
                <c:pt idx="2">
                  <c:v>0.13333333333333333</c:v>
                </c:pt>
                <c:pt idx="3">
                  <c:v>0.2233333333333333</c:v>
                </c:pt>
                <c:pt idx="4">
                  <c:v>0.40666666666666668</c:v>
                </c:pt>
                <c:pt idx="5">
                  <c:v>0.66666666666666663</c:v>
                </c:pt>
                <c:pt idx="6">
                  <c:v>0.98</c:v>
                </c:pt>
                <c:pt idx="7">
                  <c:v>1.2466666666666668</c:v>
                </c:pt>
                <c:pt idx="8">
                  <c:v>1.36</c:v>
                </c:pt>
                <c:pt idx="9">
                  <c:v>1.3466666666666667</c:v>
                </c:pt>
                <c:pt idx="10">
                  <c:v>1.3733333333333333</c:v>
                </c:pt>
                <c:pt idx="11">
                  <c:v>1.373333333333333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1!$H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Z$17:$Z$28</c:f>
              <c:numCache>
                <c:formatCode>0.00</c:formatCode>
                <c:ptCount val="12"/>
                <c:pt idx="0">
                  <c:v>0.02</c:v>
                </c:pt>
                <c:pt idx="1">
                  <c:v>9.0000000000000011E-2</c:v>
                </c:pt>
                <c:pt idx="2">
                  <c:v>0.16</c:v>
                </c:pt>
                <c:pt idx="3">
                  <c:v>0.3</c:v>
                </c:pt>
                <c:pt idx="4">
                  <c:v>0.49</c:v>
                </c:pt>
                <c:pt idx="5">
                  <c:v>0.76666666666666661</c:v>
                </c:pt>
                <c:pt idx="6">
                  <c:v>1.1066666666666667</c:v>
                </c:pt>
                <c:pt idx="7">
                  <c:v>1.3666666666666669</c:v>
                </c:pt>
                <c:pt idx="8">
                  <c:v>1.3466666666666667</c:v>
                </c:pt>
                <c:pt idx="9">
                  <c:v>1.3533333333333335</c:v>
                </c:pt>
                <c:pt idx="10">
                  <c:v>1.2933333333333332</c:v>
                </c:pt>
                <c:pt idx="11">
                  <c:v>1.3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1!$K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AC$17:$AC$28</c:f>
              <c:numCache>
                <c:formatCode>0.00</c:formatCode>
                <c:ptCount val="12"/>
                <c:pt idx="0">
                  <c:v>0.02</c:v>
                </c:pt>
                <c:pt idx="1">
                  <c:v>7.6666666666666675E-2</c:v>
                </c:pt>
                <c:pt idx="2">
                  <c:v>0.12666666666666668</c:v>
                </c:pt>
                <c:pt idx="3">
                  <c:v>0.21666666666666665</c:v>
                </c:pt>
                <c:pt idx="4">
                  <c:v>0.37999999999999995</c:v>
                </c:pt>
                <c:pt idx="5">
                  <c:v>0.64</c:v>
                </c:pt>
                <c:pt idx="6">
                  <c:v>0.98666666666666669</c:v>
                </c:pt>
                <c:pt idx="7">
                  <c:v>1.2066666666666668</c:v>
                </c:pt>
                <c:pt idx="8">
                  <c:v>1.3533333333333335</c:v>
                </c:pt>
                <c:pt idx="9">
                  <c:v>1.3933333333333333</c:v>
                </c:pt>
                <c:pt idx="10">
                  <c:v>1.3733333333333333</c:v>
                </c:pt>
                <c:pt idx="11">
                  <c:v>1.3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0156800"/>
        <c:axId val="260167552"/>
      </c:scatterChart>
      <c:valAx>
        <c:axId val="260156800"/>
        <c:scaling>
          <c:orientation val="minMax"/>
          <c:max val="6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Time (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260167552"/>
        <c:crossesAt val="1.0000000000000002E-2"/>
        <c:crossBetween val="midCat"/>
        <c:majorUnit val="1"/>
      </c:valAx>
      <c:valAx>
        <c:axId val="260167552"/>
        <c:scaling>
          <c:logBase val="10"/>
          <c:orientation val="minMax"/>
          <c:max val="1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GB" sz="1400"/>
                  <a:t>OD</a:t>
                </a:r>
                <a:r>
                  <a:rPr lang="en-GB" sz="1400" baseline="-25000"/>
                  <a:t>600nm</a:t>
                </a:r>
              </a:p>
            </c:rich>
          </c:tx>
          <c:layout>
            <c:manualLayout>
              <c:xMode val="edge"/>
              <c:yMode val="edge"/>
              <c:x val="1.461997392349218E-2"/>
              <c:y val="0.32646801284791732"/>
            </c:manualLayout>
          </c:layout>
          <c:overlay val="0"/>
        </c:title>
        <c:numFmt formatCode="0.00" sourceLinked="1"/>
        <c:majorTickMark val="out"/>
        <c:minorTickMark val="out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260156800"/>
        <c:crossesAt val="0"/>
        <c:crossBetween val="midCat"/>
      </c:valAx>
    </c:plotArea>
    <c:legend>
      <c:legendPos val="r"/>
      <c:layout>
        <c:manualLayout>
          <c:xMode val="edge"/>
          <c:yMode val="edge"/>
          <c:x val="0.25192172074560487"/>
          <c:y val="0.56796850119377129"/>
          <c:w val="0.15759848917427929"/>
          <c:h val="0.25013451443569557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3198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5849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4570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8048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6211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9509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9480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802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6803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29437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5394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7CCE3-A25E-458E-BF68-2D4CCA140D83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398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0817491"/>
              </p:ext>
            </p:extLst>
          </p:nvPr>
        </p:nvGraphicFramePr>
        <p:xfrm>
          <a:off x="110054" y="126371"/>
          <a:ext cx="4364236" cy="3052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641085" y="1806965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641085" y="2002497"/>
            <a:ext cx="1130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+ </a:t>
            </a:r>
            <a:r>
              <a:rPr lang="en-GB" sz="1200" dirty="0" err="1" smtClean="0"/>
              <a:t>pTetH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1641085" y="2186528"/>
            <a:ext cx="1181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_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20</a:t>
            </a:r>
            <a:endParaRPr lang="en-GB" i="1" dirty="0"/>
          </a:p>
        </p:txBody>
      </p:sp>
      <p:sp>
        <p:nvSpPr>
          <p:cNvPr id="8" name="TextBox 7"/>
          <p:cNvSpPr txBox="1"/>
          <p:nvPr/>
        </p:nvSpPr>
        <p:spPr>
          <a:xfrm>
            <a:off x="1641085" y="2376309"/>
            <a:ext cx="2545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_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20 </a:t>
            </a:r>
            <a:r>
              <a:rPr lang="en-GB" sz="1200" dirty="0" smtClean="0"/>
              <a:t>+ pTet-</a:t>
            </a:r>
            <a:r>
              <a:rPr lang="en-GB" sz="1200" i="1" dirty="0" smtClean="0"/>
              <a:t>OG1RF_11720</a:t>
            </a:r>
            <a:endParaRPr lang="en-GB" i="1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4970990"/>
              </p:ext>
            </p:extLst>
          </p:nvPr>
        </p:nvGraphicFramePr>
        <p:xfrm>
          <a:off x="4696536" y="171019"/>
          <a:ext cx="4346376" cy="3008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5302355"/>
              </p:ext>
            </p:extLst>
          </p:nvPr>
        </p:nvGraphicFramePr>
        <p:xfrm>
          <a:off x="110054" y="3533026"/>
          <a:ext cx="4346376" cy="3008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9296709"/>
              </p:ext>
            </p:extLst>
          </p:nvPr>
        </p:nvGraphicFramePr>
        <p:xfrm>
          <a:off x="4696536" y="3533026"/>
          <a:ext cx="4343373" cy="3008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6196102" y="1823006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6196102" y="2018538"/>
            <a:ext cx="1130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+ </a:t>
            </a:r>
            <a:r>
              <a:rPr lang="en-GB" sz="1200" dirty="0" err="1" smtClean="0"/>
              <a:t>pTetH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6196102" y="2202569"/>
            <a:ext cx="1217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_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15</a:t>
            </a:r>
            <a:endParaRPr lang="en-GB" i="1" dirty="0"/>
          </a:p>
        </p:txBody>
      </p:sp>
      <p:sp>
        <p:nvSpPr>
          <p:cNvPr id="15" name="TextBox 14"/>
          <p:cNvSpPr txBox="1"/>
          <p:nvPr/>
        </p:nvSpPr>
        <p:spPr>
          <a:xfrm>
            <a:off x="6196102" y="2392350"/>
            <a:ext cx="2545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_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15 </a:t>
            </a:r>
            <a:r>
              <a:rPr lang="en-GB" sz="1200" dirty="0" smtClean="0"/>
              <a:t>+ pTet-</a:t>
            </a:r>
            <a:r>
              <a:rPr lang="en-GB" sz="1200" i="1" dirty="0" smtClean="0"/>
              <a:t>OG1RF_11715</a:t>
            </a:r>
            <a:endParaRPr lang="en-GB" i="1" dirty="0"/>
          </a:p>
        </p:txBody>
      </p:sp>
      <p:sp>
        <p:nvSpPr>
          <p:cNvPr id="16" name="TextBox 15"/>
          <p:cNvSpPr txBox="1"/>
          <p:nvPr/>
        </p:nvSpPr>
        <p:spPr>
          <a:xfrm>
            <a:off x="6193605" y="5190929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6193605" y="5386461"/>
            <a:ext cx="1130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+ </a:t>
            </a:r>
            <a:r>
              <a:rPr lang="en-GB" sz="1200" dirty="0" err="1" smtClean="0"/>
              <a:t>pTetH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6193605" y="5570492"/>
            <a:ext cx="1181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_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07</a:t>
            </a:r>
            <a:endParaRPr lang="en-GB" i="1" dirty="0"/>
          </a:p>
        </p:txBody>
      </p:sp>
      <p:sp>
        <p:nvSpPr>
          <p:cNvPr id="19" name="TextBox 18"/>
          <p:cNvSpPr txBox="1"/>
          <p:nvPr/>
        </p:nvSpPr>
        <p:spPr>
          <a:xfrm>
            <a:off x="6193605" y="5760273"/>
            <a:ext cx="2545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_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07</a:t>
            </a:r>
            <a:r>
              <a:rPr lang="en-GB" sz="1200" dirty="0" smtClean="0"/>
              <a:t> </a:t>
            </a:r>
            <a:r>
              <a:rPr lang="en-GB" sz="1200" dirty="0" smtClean="0"/>
              <a:t>+ pTet-</a:t>
            </a:r>
            <a:r>
              <a:rPr lang="en-GB" sz="1200" i="1" dirty="0" smtClean="0"/>
              <a:t>OG1RF_11707</a:t>
            </a:r>
            <a:endParaRPr lang="en-GB" i="1" dirty="0"/>
          </a:p>
        </p:txBody>
      </p:sp>
      <p:sp>
        <p:nvSpPr>
          <p:cNvPr id="20" name="TextBox 19"/>
          <p:cNvSpPr txBox="1"/>
          <p:nvPr/>
        </p:nvSpPr>
        <p:spPr>
          <a:xfrm>
            <a:off x="1659403" y="5196276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1659403" y="5391808"/>
            <a:ext cx="1130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+ </a:t>
            </a:r>
            <a:r>
              <a:rPr lang="en-GB" sz="1200" dirty="0" err="1" smtClean="0"/>
              <a:t>pTetH</a:t>
            </a:r>
            <a:endParaRPr lang="en-GB" dirty="0"/>
          </a:p>
        </p:txBody>
      </p:sp>
      <p:sp>
        <p:nvSpPr>
          <p:cNvPr id="22" name="TextBox 21"/>
          <p:cNvSpPr txBox="1"/>
          <p:nvPr/>
        </p:nvSpPr>
        <p:spPr>
          <a:xfrm>
            <a:off x="1659403" y="5575839"/>
            <a:ext cx="1181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_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14</a:t>
            </a:r>
            <a:endParaRPr lang="en-GB" i="1" dirty="0"/>
          </a:p>
        </p:txBody>
      </p:sp>
      <p:sp>
        <p:nvSpPr>
          <p:cNvPr id="23" name="TextBox 22"/>
          <p:cNvSpPr txBox="1"/>
          <p:nvPr/>
        </p:nvSpPr>
        <p:spPr>
          <a:xfrm>
            <a:off x="1659403" y="5765620"/>
            <a:ext cx="2545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_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14 </a:t>
            </a:r>
            <a:r>
              <a:rPr lang="en-GB" sz="1200" dirty="0" smtClean="0"/>
              <a:t>+ pTet-</a:t>
            </a:r>
            <a:r>
              <a:rPr lang="en-GB" sz="1200" i="1" dirty="0" smtClean="0"/>
              <a:t>OG1RF_11714</a:t>
            </a:r>
            <a:endParaRPr lang="en-GB" i="1" dirty="0"/>
          </a:p>
        </p:txBody>
      </p:sp>
      <p:sp>
        <p:nvSpPr>
          <p:cNvPr id="24" name="TextBox 23"/>
          <p:cNvSpPr txBox="1"/>
          <p:nvPr/>
        </p:nvSpPr>
        <p:spPr>
          <a:xfrm>
            <a:off x="-5932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-5932" y="328498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4499992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499992" y="3284984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D</a:t>
            </a:r>
            <a:endParaRPr lang="en-GB" b="1" dirty="0"/>
          </a:p>
        </p:txBody>
      </p:sp>
      <p:sp>
        <p:nvSpPr>
          <p:cNvPr id="2" name="TextBox 1"/>
          <p:cNvSpPr txBox="1"/>
          <p:nvPr/>
        </p:nvSpPr>
        <p:spPr>
          <a:xfrm>
            <a:off x="4067944" y="6488668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smtClean="0"/>
              <a:t>S9 </a:t>
            </a:r>
            <a:r>
              <a:rPr lang="en-GB" sz="2000" b="1" dirty="0" smtClean="0"/>
              <a:t>Figure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2521272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1</TotalTime>
  <Words>58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</dc:creator>
  <cp:lastModifiedBy>steph</cp:lastModifiedBy>
  <cp:revision>10</cp:revision>
  <dcterms:created xsi:type="dcterms:W3CDTF">2018-11-01T14:37:25Z</dcterms:created>
  <dcterms:modified xsi:type="dcterms:W3CDTF">2019-03-18T16:16:20Z</dcterms:modified>
</cp:coreProperties>
</file>